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78" r:id="rId1"/>
  </p:sldMasterIdLst>
  <p:notesMasterIdLst>
    <p:notesMasterId r:id="rId4"/>
  </p:notesMasterIdLst>
  <p:sldIdLst>
    <p:sldId id="1581" r:id="rId2"/>
    <p:sldId id="1583" r:id="rId3"/>
  </p:sldIdLst>
  <p:sldSz cx="71993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uamin huang" initials="hh" lastIdx="1" clrIdx="0">
    <p:extLst>
      <p:ext uri="{19B8F6BF-5375-455C-9EA6-DF929625EA0E}">
        <p15:presenceInfo xmlns:p15="http://schemas.microsoft.com/office/powerpoint/2012/main" userId="33192c8c3bc553d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3" autoAdjust="0"/>
    <p:restoredTop sz="93875" autoAdjust="0"/>
  </p:normalViewPr>
  <p:slideViewPr>
    <p:cSldViewPr snapToGrid="0" snapToObjects="1">
      <p:cViewPr>
        <p:scale>
          <a:sx n="66" d="100"/>
          <a:sy n="66" d="100"/>
        </p:scale>
        <p:origin x="151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16DCB4-2E3A-5843-9692-75A7D42B0F17}" type="datetimeFigureOut">
              <a:rPr kumimoji="1" lang="zh-CN" altLang="en-US" smtClean="0"/>
              <a:t>2022/7/26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27238" y="1143000"/>
            <a:ext cx="2803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3999F1-A68A-1943-9A81-1E4F57050E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465875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296173"/>
            <a:ext cx="6119416" cy="275734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4159854"/>
            <a:ext cx="5399485" cy="1912175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C2A4962-8B89-4438-A546-08CCB94E4B2A}" type="datetime1">
              <a:rPr lang="zh-CN" altLang="en-US" smtClean="0">
                <a:solidFill>
                  <a:srgbClr val="000000"/>
                </a:solidFill>
              </a:rPr>
              <a:t>2022/7/26</a:t>
            </a:fld>
            <a:endParaRPr lang="en-US" altLang="zh-CN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zh-CN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  <p:pic>
        <p:nvPicPr>
          <p:cNvPr id="7" name="Picture 8" descr="StandXB">
            <a:extLst>
              <a:ext uri="{FF2B5EF4-FFF2-40B4-BE49-F238E27FC236}">
                <a16:creationId xmlns:a16="http://schemas.microsoft.com/office/drawing/2014/main" id="{8A75D9C7-88FC-4DBA-AD71-AE1B0D009847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grayscl/>
            <a:lum bright="70000" contrast="-7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H="1" flipV="1">
            <a:off x="5526977" y="5789696"/>
            <a:ext cx="1019903" cy="1446507"/>
          </a:xfrm>
          <a:prstGeom prst="rect">
            <a:avLst/>
          </a:prstGeom>
          <a:solidFill>
            <a:srgbClr val="FF99CC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81675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2518842-D7EF-4C8D-9B66-C4D409D12E16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D075752-8A11-4086-AC5B-1A78CEE5282B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51388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421669"/>
            <a:ext cx="1552352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421669"/>
            <a:ext cx="4567064" cy="671186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32EAC0AF-B333-4BD0-8E6A-EAEB4FB2A5C8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D1D3EF4-EB0F-4C5E-BA79-CF33A5128171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433979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B347DF1B-49FA-4684-AE8D-D9DAA676E3AE}" type="datetime1">
              <a:rPr lang="zh-CN" altLang="en-US" smtClean="0"/>
              <a:t>2022/7/26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61667623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A9C7E17C-D57F-4496-B15F-83C2C893931F}" type="datetime1">
              <a:rPr lang="zh-CN" altLang="en-US" smtClean="0"/>
              <a:t>2022/7/26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8325852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521371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9CB48-D6AF-495D-8562-6BA91E7A3CD0}" type="datetime1">
              <a:rPr lang="zh-CN" altLang="en-US" smtClean="0"/>
              <a:t>2022/7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CDA0428-29F7-42D3-B99F-6C89127BB1BE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6095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974512"/>
            <a:ext cx="6209407" cy="3294515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5300194"/>
            <a:ext cx="6209407" cy="1732508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06CBD-878C-4D61-8EF8-D2D164538046}" type="datetime1">
              <a:rPr lang="zh-CN" altLang="en-US" smtClean="0"/>
              <a:t>2022/7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6301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108344"/>
            <a:ext cx="3059708" cy="50251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108344"/>
            <a:ext cx="3059708" cy="50251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DE85F33-63B3-4876-93FE-94AD4955B47D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CDA0428-29F7-42D3-B99F-6C89127BB1BE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60802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421671"/>
            <a:ext cx="6209407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941510"/>
            <a:ext cx="3045646" cy="95150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893014"/>
            <a:ext cx="3045646" cy="42551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941510"/>
            <a:ext cx="3060646" cy="95150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893014"/>
            <a:ext cx="3060646" cy="42551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FE97A31-7840-47B1-8E08-A943D6772A04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27974B9-7900-454A-8910-A29999C49100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7622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F7A47F6-726F-4DA0-BAF4-F407CFDA7D0C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D74C45A-FCBA-4B8F-B771-C1D54FD49C6B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18053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A31372F-FB32-4820-A588-216D78BBE687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3C5FC3-206B-4EAF-9EDB-DB38621EF872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6158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28002"/>
            <a:ext cx="2321966" cy="1848009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140341"/>
            <a:ext cx="3644652" cy="5628360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376011"/>
            <a:ext cx="2321966" cy="440185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344E412-8426-4E4B-A924-5796E1823C36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AB37276-A015-4B37-A369-4DC3BADFDF4F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1752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28002"/>
            <a:ext cx="2321966" cy="1848009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140341"/>
            <a:ext cx="3644652" cy="5628360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376011"/>
            <a:ext cx="2321966" cy="440185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EC4A3D7-8644-4466-AD16-E552A2534B08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123599C-E6FE-424E-8D0D-48F621772163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3077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421671"/>
            <a:ext cx="6209407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108344"/>
            <a:ext cx="6209407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7340703"/>
            <a:ext cx="1619845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0E5BBD95-064F-404D-8DD2-DF8CA2246335}" type="datetime1">
              <a:rPr lang="zh-CN" altLang="en-US" smtClean="0"/>
              <a:t>2022/7/26</a:t>
            </a:fld>
            <a:endParaRPr lang="zh-CN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7340703"/>
            <a:ext cx="242976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7340703"/>
            <a:ext cx="1619845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D1D3EF4-EB0F-4C5E-BA79-CF33A5128171}" type="slidenum">
              <a:rPr lang="en-US" altLang="zh-CN" smtClean="0">
                <a:solidFill>
                  <a:srgbClr val="000000"/>
                </a:solidFill>
              </a:rPr>
              <a:t>‹#›</a:t>
            </a:fld>
            <a:endParaRPr lang="en-US" altLang="zh-CN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58294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9" r:id="rId1"/>
    <p:sldLayoutId id="2147483880" r:id="rId2"/>
    <p:sldLayoutId id="2147483881" r:id="rId3"/>
    <p:sldLayoutId id="2147483882" r:id="rId4"/>
    <p:sldLayoutId id="2147483883" r:id="rId5"/>
    <p:sldLayoutId id="2147483884" r:id="rId6"/>
    <p:sldLayoutId id="2147483885" r:id="rId7"/>
    <p:sldLayoutId id="2147483886" r:id="rId8"/>
    <p:sldLayoutId id="2147483887" r:id="rId9"/>
    <p:sldLayoutId id="2147483888" r:id="rId10"/>
    <p:sldLayoutId id="2147483889" r:id="rId11"/>
    <p:sldLayoutId id="2147483764" r:id="rId12"/>
    <p:sldLayoutId id="2147483765" r:id="rId13"/>
    <p:sldLayoutId id="2147483766" r:id="rId14"/>
  </p:sldLayoutIdLst>
  <p:hf hdr="0" ftr="0" dt="0"/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05677766-6CCD-40AB-8810-4A2F53F92655}"/>
              </a:ext>
            </a:extLst>
          </p:cNvPr>
          <p:cNvSpPr txBox="1"/>
          <p:nvPr/>
        </p:nvSpPr>
        <p:spPr>
          <a:xfrm>
            <a:off x="650736" y="2154904"/>
            <a:ext cx="3017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5828F6B3-2B88-4DFC-8FE4-92720E06B8E3}"/>
              </a:ext>
            </a:extLst>
          </p:cNvPr>
          <p:cNvSpPr txBox="1"/>
          <p:nvPr/>
        </p:nvSpPr>
        <p:spPr>
          <a:xfrm>
            <a:off x="650736" y="641931"/>
            <a:ext cx="3337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C12D30D8-C4CA-40BE-BBE6-1D2441D24B45}"/>
              </a:ext>
            </a:extLst>
          </p:cNvPr>
          <p:cNvGrpSpPr/>
          <p:nvPr/>
        </p:nvGrpSpPr>
        <p:grpSpPr>
          <a:xfrm>
            <a:off x="1115073" y="890009"/>
            <a:ext cx="1235724" cy="800495"/>
            <a:chOff x="2383322" y="4325482"/>
            <a:chExt cx="1454451" cy="339581"/>
          </a:xfrm>
        </p:grpSpPr>
        <p:sp>
          <p:nvSpPr>
            <p:cNvPr id="48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2438292" y="4422057"/>
              <a:ext cx="421120" cy="979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HA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49" name="文本框 102">
              <a:extLst>
                <a:ext uri="{FF2B5EF4-FFF2-40B4-BE49-F238E27FC236}">
                  <a16:creationId xmlns:a16="http://schemas.microsoft.com/office/drawing/2014/main" id="{D557AAAD-7C9B-401A-8AE5-F23551FEEAAC}"/>
                </a:ext>
              </a:extLst>
            </p:cNvPr>
            <p:cNvSpPr txBox="1"/>
            <p:nvPr/>
          </p:nvSpPr>
          <p:spPr>
            <a:xfrm>
              <a:off x="2383322" y="4567141"/>
              <a:ext cx="481496" cy="979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RLS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51" name="TextBox 114">
              <a:extLst>
                <a:ext uri="{FF2B5EF4-FFF2-40B4-BE49-F238E27FC236}">
                  <a16:creationId xmlns:a16="http://schemas.microsoft.com/office/drawing/2014/main" id="{DC9FBC4E-FF35-4F07-8CC4-F1916781F102}"/>
                </a:ext>
              </a:extLst>
            </p:cNvPr>
            <p:cNvSpPr txBox="1"/>
            <p:nvPr/>
          </p:nvSpPr>
          <p:spPr>
            <a:xfrm>
              <a:off x="3031757" y="4325482"/>
              <a:ext cx="806016" cy="979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i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9</a:t>
              </a:r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-OE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52" name="TextBox 115">
              <a:extLst>
                <a:ext uri="{FF2B5EF4-FFF2-40B4-BE49-F238E27FC236}">
                  <a16:creationId xmlns:a16="http://schemas.microsoft.com/office/drawing/2014/main" id="{AA7616A1-9E22-4CB2-BA79-57AA8281CF53}"/>
                </a:ext>
              </a:extLst>
            </p:cNvPr>
            <p:cNvSpPr txBox="1"/>
            <p:nvPr/>
          </p:nvSpPr>
          <p:spPr>
            <a:xfrm>
              <a:off x="2785147" y="4326098"/>
              <a:ext cx="443761" cy="979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WT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</p:grpSp>
      <p:sp>
        <p:nvSpPr>
          <p:cNvPr id="21" name="矩形 20">
            <a:extLst>
              <a:ext uri="{FF2B5EF4-FFF2-40B4-BE49-F238E27FC236}">
                <a16:creationId xmlns:a16="http://schemas.microsoft.com/office/drawing/2014/main" id="{2155695C-8CE3-415D-842E-964AD8250351}"/>
              </a:ext>
            </a:extLst>
          </p:cNvPr>
          <p:cNvSpPr/>
          <p:nvPr/>
        </p:nvSpPr>
        <p:spPr>
          <a:xfrm>
            <a:off x="0" y="0"/>
            <a:ext cx="130147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6E40A59-C06A-491E-A65D-0909F2FEE2F0}"/>
              </a:ext>
            </a:extLst>
          </p:cNvPr>
          <p:cNvPicPr>
            <a:picLocks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t="49735" b="39555"/>
          <a:stretch/>
        </p:blipFill>
        <p:spPr>
          <a:xfrm>
            <a:off x="1524155" y="1439622"/>
            <a:ext cx="504000" cy="291600"/>
          </a:xfrm>
          <a:prstGeom prst="rect">
            <a:avLst/>
          </a:prstGeom>
          <a:ln w="12700">
            <a:solidFill>
              <a:schemeClr val="tx1">
                <a:lumMod val="85000"/>
                <a:lumOff val="15000"/>
              </a:schemeClr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7835659-81FA-49E4-8D72-A0ADAAA61099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t="32586" b="25792"/>
          <a:stretch/>
        </p:blipFill>
        <p:spPr>
          <a:xfrm>
            <a:off x="1524155" y="1102460"/>
            <a:ext cx="504000" cy="291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3C020E14-EC76-13ED-127D-A0D441293CD7}"/>
              </a:ext>
            </a:extLst>
          </p:cNvPr>
          <p:cNvSpPr txBox="1"/>
          <p:nvPr/>
        </p:nvSpPr>
        <p:spPr>
          <a:xfrm>
            <a:off x="179656" y="5231576"/>
            <a:ext cx="684000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Figure S1 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Identification of </a:t>
            </a:r>
            <a:r>
              <a:rPr lang="en-US" altLang="zh-CN" sz="14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BAG9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-OE plants and</a:t>
            </a:r>
            <a:r>
              <a:rPr lang="en-US" altLang="zh-CN" sz="14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 bag9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 mutants. The control sample was wild-type (WT). (A) Western blotting analysis of transgenic plants expressing the HA-tagged </a:t>
            </a:r>
            <a:r>
              <a:rPr lang="en-US" altLang="zh-CN" sz="14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BAG9-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OE plants. (B) </a:t>
            </a:r>
            <a:r>
              <a:rPr lang="en-US" altLang="zh-CN" sz="14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bag9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 mutant contained a 4 bp deletion in the exon of the </a:t>
            </a:r>
            <a:r>
              <a:rPr lang="en-US" altLang="zh-CN" sz="14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BAG9 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gene. The deletion part was marked in dashes and sgRNA was marked in a red line. RLS, Rubisco large subunit.</a:t>
            </a:r>
            <a:endParaRPr lang="zh-CN" altLang="en-US" sz="1400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EF071629-B4EF-424B-9A26-188E29DD3FB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81557" y="2709025"/>
            <a:ext cx="5938099" cy="2382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75001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E3F1E3B9-F30C-4296-A8D2-CE4C2963F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53C5FC3-206B-4EAF-9EDB-DB38621EF872}" type="slidenum">
              <a:rPr lang="en-US" altLang="zh-CN" smtClean="0">
                <a:solidFill>
                  <a:srgbClr val="000000"/>
                </a:solidFill>
              </a:rPr>
              <a:t>2</a:t>
            </a:fld>
            <a:endParaRPr lang="en-US" altLang="zh-CN">
              <a:solidFill>
                <a:srgbClr val="000000"/>
              </a:solidFill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A3CE2114-7AD1-46F3-BEA9-71D66BCBB914}"/>
              </a:ext>
            </a:extLst>
          </p:cNvPr>
          <p:cNvSpPr/>
          <p:nvPr/>
        </p:nvSpPr>
        <p:spPr>
          <a:xfrm>
            <a:off x="0" y="0"/>
            <a:ext cx="130147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</a:t>
            </a:r>
          </a:p>
        </p:txBody>
      </p:sp>
      <p:grpSp>
        <p:nvGrpSpPr>
          <p:cNvPr id="6" name="组合 5"/>
          <p:cNvGrpSpPr/>
          <p:nvPr/>
        </p:nvGrpSpPr>
        <p:grpSpPr>
          <a:xfrm>
            <a:off x="1440180" y="1015501"/>
            <a:ext cx="4296886" cy="4650988"/>
            <a:chOff x="1440180" y="1015501"/>
            <a:chExt cx="4296886" cy="4650988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FB004188-3120-4905-8B30-40F225D8F2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09" t="19792" r="18940" b="22357"/>
            <a:stretch/>
          </p:blipFill>
          <p:spPr>
            <a:xfrm>
              <a:off x="1889760" y="1015501"/>
              <a:ext cx="3847306" cy="3541259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FB004188-3120-4905-8B30-40F225D8F2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64" t="77768" r="18941" b="2904"/>
            <a:stretch/>
          </p:blipFill>
          <p:spPr>
            <a:xfrm>
              <a:off x="1440180" y="4483348"/>
              <a:ext cx="4296886" cy="1183141"/>
            </a:xfrm>
            <a:prstGeom prst="rect">
              <a:avLst/>
            </a:prstGeom>
          </p:spPr>
        </p:pic>
        <p:sp>
          <p:nvSpPr>
            <p:cNvPr id="7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7800" y="1015501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1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8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7800" y="2471309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5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0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6415" y="2072767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4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1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7603" y="1351076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2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2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6415" y="2806884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6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3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6415" y="3189503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7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4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7603" y="1733695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3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5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6415" y="3541001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8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6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6415" y="3881177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9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  <p:sp>
          <p:nvSpPr>
            <p:cNvPr id="17" name="文本框 102">
              <a:extLst>
                <a:ext uri="{FF2B5EF4-FFF2-40B4-BE49-F238E27FC236}">
                  <a16:creationId xmlns:a16="http://schemas.microsoft.com/office/drawing/2014/main" id="{5E663DDA-85AB-45BD-9ED1-FB1E1742017D}"/>
                </a:ext>
              </a:extLst>
            </p:cNvPr>
            <p:cNvSpPr txBox="1"/>
            <p:nvPr/>
          </p:nvSpPr>
          <p:spPr>
            <a:xfrm>
              <a:off x="1446415" y="426269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>
                  <a:latin typeface="Times New Roman" panose="02020503050405090304" pitchFamily="18" charset="0"/>
                  <a:cs typeface="Times New Roman" panose="02020503050405090304" pitchFamily="18" charset="0"/>
                </a:rPr>
                <a:t>BAG10</a:t>
              </a:r>
              <a:endParaRPr lang="zh-CN" altLang="en-US" sz="900" b="1" dirty="0">
                <a:latin typeface="Times New Roman" panose="02020503050405090304" pitchFamily="18" charset="0"/>
                <a:cs typeface="Times New Roman" panose="02020503050405090304" pitchFamily="18" charset="0"/>
              </a:endParaRPr>
            </a:p>
          </p:txBody>
        </p: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1831B0DB-65F9-8828-DD3C-F9A93C6EE68E}"/>
              </a:ext>
            </a:extLst>
          </p:cNvPr>
          <p:cNvSpPr txBox="1"/>
          <p:nvPr/>
        </p:nvSpPr>
        <p:spPr>
          <a:xfrm>
            <a:off x="179656" y="5882816"/>
            <a:ext cx="6840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Figure S2 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Analysis of </a:t>
            </a:r>
            <a:r>
              <a:rPr lang="en-US" altLang="zh-CN" sz="14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cis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-acting elements in the promoter region of </a:t>
            </a:r>
            <a:r>
              <a:rPr lang="en-US" altLang="zh-CN" sz="14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BAGs</a:t>
            </a:r>
            <a:r>
              <a:rPr lang="en-US" altLang="zh-CN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ahoma" panose="020B0604030504040204" pitchFamily="34" charset="0"/>
              </a:rPr>
              <a:t>. Upstream 3 kb promoter sequence was used for analysis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301133586"/>
      </p:ext>
    </p:extLst>
  </p:cSld>
  <p:clrMapOvr>
    <a:masterClrMapping/>
  </p:clrMapOvr>
</p:sld>
</file>

<file path=ppt/theme/theme1.xml><?xml version="1.0" encoding="utf-8"?>
<a:theme xmlns:a="http://schemas.openxmlformats.org/drawingml/2006/main" name="2_Profil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57</TotalTime>
  <Words>117</Words>
  <Application>Microsoft Office PowerPoint</Application>
  <PresentationFormat>自定义</PresentationFormat>
  <Paragraphs>2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Calibri</vt:lpstr>
      <vt:lpstr>Calibri Light</vt:lpstr>
      <vt:lpstr>Tahoma</vt:lpstr>
      <vt:lpstr>Times New Roman</vt:lpstr>
      <vt:lpstr>2_Profile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huamin huang</cp:lastModifiedBy>
  <cp:revision>133</cp:revision>
  <dcterms:created xsi:type="dcterms:W3CDTF">2022-02-28T13:35:53Z</dcterms:created>
  <dcterms:modified xsi:type="dcterms:W3CDTF">2022-07-26T08:45:32Z</dcterms:modified>
</cp:coreProperties>
</file>